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4"/>
  </p:notesMasterIdLst>
  <p:sldIdLst>
    <p:sldId id="257" r:id="rId2"/>
    <p:sldId id="259" r:id="rId3"/>
  </p:sldIdLst>
  <p:sldSz cx="9144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79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/>
    <p:restoredTop sz="80728"/>
  </p:normalViewPr>
  <p:slideViewPr>
    <p:cSldViewPr snapToGrid="0" snapToObjects="1" showGuides="1">
      <p:cViewPr varScale="1">
        <p:scale>
          <a:sx n="38" d="100"/>
          <a:sy n="38" d="100"/>
        </p:scale>
        <p:origin x="4320" y="208"/>
      </p:cViewPr>
      <p:guideLst>
        <p:guide orient="horz" pos="5079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DEBC46-9D41-4544-BFAA-F4AAC38B0554}" type="datetimeFigureOut">
              <a:rPr lang="en-US" smtClean="0"/>
              <a:t>4/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69DE75-2AF2-BC49-8CA3-0FB8A70D2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10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S4. Comparison of individual anti-HER2 agents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A)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S and (B) CNS-specific PFS of patients who receive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stuzuma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ersus alternative agents. (C)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S and (D) CNS-specific PFS of patients who receive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tuzuma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ersus alternative agents. (E)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S and (F) CNS-specific PFS of patients who received T-DM1 versus alternative agents. (G)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S and (H) CNS-specific PFS of patients who receive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patini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ersus alternative agents.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-values calculated with Log-Rank tes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69DE75-2AF2-BC49-8CA3-0FB8A70D2F1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5913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660416"/>
            <a:ext cx="7772400" cy="5659496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8538164"/>
            <a:ext cx="6858000" cy="3924769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865481"/>
            <a:ext cx="1971675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865481"/>
            <a:ext cx="5800725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4052716"/>
            <a:ext cx="7886700" cy="676204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10878731"/>
            <a:ext cx="7886700" cy="3555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4327407"/>
            <a:ext cx="38862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4327407"/>
            <a:ext cx="38862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65485"/>
            <a:ext cx="78867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984979"/>
            <a:ext cx="3868340" cy="195297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937956"/>
            <a:ext cx="3868340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984979"/>
            <a:ext cx="3887391" cy="195297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937956"/>
            <a:ext cx="3887391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83733"/>
            <a:ext cx="2949178" cy="3793067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340567"/>
            <a:ext cx="4629150" cy="1155229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876800"/>
            <a:ext cx="2949178" cy="903487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83733"/>
            <a:ext cx="2949178" cy="3793067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340567"/>
            <a:ext cx="4629150" cy="11552296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876800"/>
            <a:ext cx="2949178" cy="903487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865485"/>
            <a:ext cx="78867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4327407"/>
            <a:ext cx="78867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5066908"/>
            <a:ext cx="20574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12CA6-0941-5E40-A4F8-58CD1A0EA56D}" type="datetimeFigureOut">
              <a:rPr lang="en-US" smtClean="0"/>
              <a:t>4/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5066908"/>
            <a:ext cx="30861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5066908"/>
            <a:ext cx="20574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652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1732213"/>
              </p:ext>
            </p:extLst>
          </p:nvPr>
        </p:nvGraphicFramePr>
        <p:xfrm>
          <a:off x="-123097" y="2582208"/>
          <a:ext cx="4642034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51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8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8597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5451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9413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8393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out </a:t>
                      </a:r>
                      <a:r>
                        <a:rPr lang="en-US" sz="800" dirty="0" err="1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astuzumab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 </a:t>
                      </a:r>
                      <a:r>
                        <a:rPr lang="en-US" sz="800" dirty="0" err="1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astuzumab</a:t>
                      </a:r>
                      <a:endParaRPr lang="en-US" sz="8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8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-173518" y="1258918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48129" y="199477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63171" y="159828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63171" y="12017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63171" y="80530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78211" y="40881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72073" y="2516008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180398" y="22576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867668" y="225768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530444" y="22576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248976" y="22576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977782" y="225768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62933" y="203199"/>
            <a:ext cx="351377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0147426"/>
              </p:ext>
            </p:extLst>
          </p:nvPr>
        </p:nvGraphicFramePr>
        <p:xfrm>
          <a:off x="4488619" y="2582209"/>
          <a:ext cx="4642034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51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8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41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6924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5872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7640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out </a:t>
                      </a:r>
                      <a:r>
                        <a:rPr lang="en-US" sz="800" dirty="0" err="1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astuzumab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8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 </a:t>
                      </a:r>
                      <a:r>
                        <a:rPr lang="en-US" sz="800" dirty="0" err="1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astuzumab</a:t>
                      </a:r>
                      <a:endParaRPr lang="en-US" sz="8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6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23" name="TextBox 22"/>
          <p:cNvSpPr txBox="1"/>
          <p:nvPr/>
        </p:nvSpPr>
        <p:spPr>
          <a:xfrm rot="16200000">
            <a:off x="4271283" y="1244186"/>
            <a:ext cx="21071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charset="0"/>
                <a:ea typeface="Arial" charset="0"/>
                <a:cs typeface="Arial" charset="0"/>
              </a:rPr>
              <a:t>Progression-Free Survival (%)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559845" y="199477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474887" y="159828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474887" y="12017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474887" y="8053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389927" y="40881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483789" y="2516009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792114" y="22576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448562" y="225768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141524" y="225768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849782" y="225768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8566132" y="225768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4649249" y="2031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aphicFrame>
        <p:nvGraphicFramePr>
          <p:cNvPr id="39" name="Table 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7702257"/>
              </p:ext>
            </p:extLst>
          </p:nvPr>
        </p:nvGraphicFramePr>
        <p:xfrm>
          <a:off x="-123098" y="6447752"/>
          <a:ext cx="4695097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683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484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366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026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1083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8413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out </a:t>
                      </a:r>
                      <a:r>
                        <a:rPr lang="en-US" sz="800" dirty="0" err="1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ertuzumab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5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 </a:t>
                      </a:r>
                      <a:r>
                        <a:rPr lang="en-US" sz="800" dirty="0" err="1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ertuzumab</a:t>
                      </a:r>
                      <a:endParaRPr lang="en-US" sz="8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0" name="TextBox 39"/>
          <p:cNvSpPr txBox="1"/>
          <p:nvPr/>
        </p:nvSpPr>
        <p:spPr>
          <a:xfrm rot="16200000">
            <a:off x="-173518" y="5124462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948129" y="586031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863171" y="54638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863171" y="50673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863171" y="467084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778211" y="427435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872073" y="6381552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180398" y="61232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869214" y="612322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537900" y="612322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262342" y="612322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994876" y="612322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62933" y="419574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graphicFrame>
        <p:nvGraphicFramePr>
          <p:cNvPr id="56" name="Table 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7408020"/>
              </p:ext>
            </p:extLst>
          </p:nvPr>
        </p:nvGraphicFramePr>
        <p:xfrm>
          <a:off x="4387019" y="6447753"/>
          <a:ext cx="4618657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185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2819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15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4736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7394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0903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out </a:t>
                      </a:r>
                      <a:r>
                        <a:rPr lang="en-US" sz="800" dirty="0" err="1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ertuzumab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3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 </a:t>
                      </a:r>
                      <a:r>
                        <a:rPr lang="en-US" sz="800" dirty="0" err="1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ertuzumab</a:t>
                      </a:r>
                      <a:endParaRPr lang="en-US" sz="8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57" name="TextBox 56"/>
          <p:cNvSpPr txBox="1"/>
          <p:nvPr/>
        </p:nvSpPr>
        <p:spPr>
          <a:xfrm rot="16200000">
            <a:off x="4211642" y="5100683"/>
            <a:ext cx="20714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charset="0"/>
                <a:ea typeface="Arial" charset="0"/>
                <a:cs typeface="Arial" charset="0"/>
              </a:rPr>
              <a:t>Progression-Free Survival (%)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483645" y="586031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398687" y="546382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398687" y="506733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5398687" y="467084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5313727" y="427436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5432989" y="6381553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690514" y="612322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6387310" y="61232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7062852" y="612322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7806850" y="612322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8550848" y="612322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4649249" y="419574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graphicFrame>
        <p:nvGraphicFramePr>
          <p:cNvPr id="73" name="Table 7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1895988"/>
              </p:ext>
            </p:extLst>
          </p:nvPr>
        </p:nvGraphicFramePr>
        <p:xfrm>
          <a:off x="-40461" y="10346494"/>
          <a:ext cx="4493533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476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40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611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7972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2717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6369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</a:t>
                      </a:r>
                    </a:p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ithout T-DM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3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</a:t>
                      </a:r>
                    </a:p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ith T-DM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74" name="TextBox 73"/>
          <p:cNvSpPr txBox="1"/>
          <p:nvPr/>
        </p:nvSpPr>
        <p:spPr>
          <a:xfrm rot="16200000">
            <a:off x="-198918" y="9023204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922729" y="975905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837771" y="93625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837771" y="896608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837771" y="85695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752811" y="817310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846673" y="10280294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1141668" y="100219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1835722" y="1002196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2535666" y="1002196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3288747" y="1002196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4031992" y="1002196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62933" y="806908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graphicFrame>
        <p:nvGraphicFramePr>
          <p:cNvPr id="90" name="Table 8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0009929"/>
              </p:ext>
            </p:extLst>
          </p:nvPr>
        </p:nvGraphicFramePr>
        <p:xfrm>
          <a:off x="4570857" y="10346495"/>
          <a:ext cx="4451762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012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661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9484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9465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7975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0460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</a:t>
                      </a:r>
                    </a:p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ithout T-DM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</a:t>
                      </a:r>
                    </a:p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ith T-DM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91" name="TextBox 90"/>
          <p:cNvSpPr txBox="1"/>
          <p:nvPr/>
        </p:nvSpPr>
        <p:spPr>
          <a:xfrm rot="16200000">
            <a:off x="4141784" y="9043883"/>
            <a:ext cx="2211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charset="0"/>
                <a:ea typeface="Arial" charset="0"/>
                <a:cs typeface="Arial" charset="0"/>
              </a:rPr>
              <a:t>Progression-Free Survival (%)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483645" y="975906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5398687" y="936257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5398687" y="896608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5398687" y="856959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5313727" y="817310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5394889" y="10280295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5715914" y="1002196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4649249" y="806908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  <p:graphicFrame>
        <p:nvGraphicFramePr>
          <p:cNvPr id="108" name="Table 10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5635939"/>
              </p:ext>
            </p:extLst>
          </p:nvPr>
        </p:nvGraphicFramePr>
        <p:xfrm>
          <a:off x="-103074" y="14291502"/>
          <a:ext cx="4675074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51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792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5147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out </a:t>
                      </a:r>
                      <a:r>
                        <a:rPr lang="en-US" sz="800" dirty="0" err="1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patinib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2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 </a:t>
                      </a:r>
                      <a:r>
                        <a:rPr lang="en-US" sz="800" dirty="0" err="1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patinib</a:t>
                      </a:r>
                      <a:endParaRPr lang="en-US" sz="8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09" name="TextBox 108"/>
          <p:cNvSpPr txBox="1"/>
          <p:nvPr/>
        </p:nvSpPr>
        <p:spPr>
          <a:xfrm rot="16200000">
            <a:off x="-172745" y="12968212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948902" y="137040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863944" y="1330757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863944" y="129110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863944" y="125145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778984" y="1211810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892096" y="14225302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1149621" y="1396697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1856869" y="1396697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2572871" y="1396697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3331929" y="1396697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4090987" y="1396697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62933" y="12014093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graphicFrame>
        <p:nvGraphicFramePr>
          <p:cNvPr id="124" name="Table 1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5014126"/>
              </p:ext>
            </p:extLst>
          </p:nvPr>
        </p:nvGraphicFramePr>
        <p:xfrm>
          <a:off x="4495753" y="14291503"/>
          <a:ext cx="4668270" cy="883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51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8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930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969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out </a:t>
                      </a:r>
                      <a:r>
                        <a:rPr lang="en-US" sz="800" dirty="0" err="1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patinib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1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Treatment with </a:t>
                      </a:r>
                      <a:r>
                        <a:rPr lang="en-US" sz="800" dirty="0" err="1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apatinib</a:t>
                      </a:r>
                      <a:endParaRPr lang="en-US" sz="8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25" name="TextBox 124"/>
          <p:cNvSpPr txBox="1"/>
          <p:nvPr/>
        </p:nvSpPr>
        <p:spPr>
          <a:xfrm rot="16200000">
            <a:off x="4307722" y="12919174"/>
            <a:ext cx="20717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charset="0"/>
                <a:ea typeface="Arial" charset="0"/>
                <a:cs typeface="Arial" charset="0"/>
              </a:rPr>
              <a:t>Progression-Free Survival (%)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5579868" y="1370406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5494910" y="1330757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5494910" y="129110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5494910" y="125145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5409950" y="1211811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5503812" y="14225303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5786737" y="1396697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6497460" y="1396697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7200762" y="1396697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7959820" y="1396697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8693478" y="1396697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9873FED3-8CBD-ABA8-195C-ABEE6E10649E}"/>
              </a:ext>
            </a:extLst>
          </p:cNvPr>
          <p:cNvSpPr txBox="1"/>
          <p:nvPr/>
        </p:nvSpPr>
        <p:spPr>
          <a:xfrm>
            <a:off x="4649249" y="120140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H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CFA81D4E-D03C-D54E-8EA9-D2F3AB806004}"/>
              </a:ext>
            </a:extLst>
          </p:cNvPr>
          <p:cNvSpPr txBox="1"/>
          <p:nvPr/>
        </p:nvSpPr>
        <p:spPr>
          <a:xfrm>
            <a:off x="5259825" y="15889944"/>
            <a:ext cx="3844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Lazarato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3849" y="455732"/>
            <a:ext cx="3075931" cy="179298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852969" y="607719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823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6691" y="460825"/>
            <a:ext cx="3066375" cy="1796857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7464685" y="607720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365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1648" y="4329385"/>
            <a:ext cx="3111491" cy="1807179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2852969" y="4473263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560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3074" y="4329385"/>
            <a:ext cx="3150199" cy="1817728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>
            <a:off x="7388485" y="4473264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354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6218" y="8230420"/>
            <a:ext cx="3175014" cy="1783759"/>
          </a:xfrm>
          <a:prstGeom prst="rect">
            <a:avLst/>
          </a:prstGeom>
        </p:spPr>
      </p:pic>
      <p:sp>
        <p:nvSpPr>
          <p:cNvPr id="98" name="TextBox 97"/>
          <p:cNvSpPr txBox="1"/>
          <p:nvPr/>
        </p:nvSpPr>
        <p:spPr>
          <a:xfrm>
            <a:off x="7388485" y="8372006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451</a:t>
            </a: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9811" y="8234672"/>
            <a:ext cx="3204200" cy="1801386"/>
          </a:xfrm>
          <a:prstGeom prst="rect">
            <a:avLst/>
          </a:prstGeom>
        </p:spPr>
      </p:pic>
      <p:sp>
        <p:nvSpPr>
          <p:cNvPr id="81" name="TextBox 80"/>
          <p:cNvSpPr txBox="1"/>
          <p:nvPr/>
        </p:nvSpPr>
        <p:spPr>
          <a:xfrm>
            <a:off x="2827569" y="8372005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690</a:t>
            </a:r>
          </a:p>
        </p:txBody>
      </p:sp>
      <p:pic>
        <p:nvPicPr>
          <p:cNvPr id="89" name="Picture 8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2965" y="12163806"/>
            <a:ext cx="3226694" cy="1812794"/>
          </a:xfrm>
          <a:prstGeom prst="rect">
            <a:avLst/>
          </a:prstGeom>
        </p:spPr>
      </p:pic>
      <p:sp>
        <p:nvSpPr>
          <p:cNvPr id="116" name="TextBox 115"/>
          <p:cNvSpPr txBox="1"/>
          <p:nvPr/>
        </p:nvSpPr>
        <p:spPr>
          <a:xfrm>
            <a:off x="2853742" y="12317013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094</a:t>
            </a:r>
          </a:p>
        </p:txBody>
      </p:sp>
      <p:pic>
        <p:nvPicPr>
          <p:cNvPr id="99" name="Picture 98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6973" y="12166120"/>
            <a:ext cx="3206465" cy="1810480"/>
          </a:xfrm>
          <a:prstGeom prst="rect">
            <a:avLst/>
          </a:prstGeom>
        </p:spPr>
      </p:pic>
      <p:sp>
        <p:nvSpPr>
          <p:cNvPr id="148" name="TextBox 147"/>
          <p:cNvSpPr txBox="1"/>
          <p:nvPr/>
        </p:nvSpPr>
        <p:spPr>
          <a:xfrm>
            <a:off x="7562111" y="12270748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021</a:t>
            </a:r>
          </a:p>
        </p:txBody>
      </p:sp>
    </p:spTree>
    <p:extLst>
      <p:ext uri="{BB962C8B-B14F-4D97-AF65-F5344CB8AC3E}">
        <p14:creationId xmlns:p14="http://schemas.microsoft.com/office/powerpoint/2010/main" val="5533618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95300" y="749638"/>
            <a:ext cx="8153400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Supplemental Figure S4. Comparison of individual anti-HER2 agents.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 (A)</a:t>
            </a:r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OS and (B) PFS of patients who received </a:t>
            </a:r>
            <a:r>
              <a:rPr lang="en-US" sz="2400" dirty="0" err="1">
                <a:latin typeface="Arial" charset="0"/>
                <a:ea typeface="Arial" charset="0"/>
                <a:cs typeface="Arial" charset="0"/>
              </a:rPr>
              <a:t>trastuzumab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 versus alternative agents. (C)</a:t>
            </a:r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OS and (D) PFS of patients who received </a:t>
            </a:r>
            <a:r>
              <a:rPr lang="en-US" sz="2400" dirty="0" err="1">
                <a:latin typeface="Arial" charset="0"/>
                <a:ea typeface="Arial" charset="0"/>
                <a:cs typeface="Arial" charset="0"/>
              </a:rPr>
              <a:t>pertuzumab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 versus alternative agents. (E)</a:t>
            </a:r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OS and (F) PFS of patients who received T-DM1 versus alternative agents. (G)</a:t>
            </a:r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OS and (H) PFS of patients who received </a:t>
            </a:r>
            <a:r>
              <a:rPr lang="en-US" sz="2400" dirty="0" err="1">
                <a:latin typeface="Arial" charset="0"/>
                <a:ea typeface="Arial" charset="0"/>
                <a:cs typeface="Arial" charset="0"/>
              </a:rPr>
              <a:t>lapatinib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 versus alternative agents. P-values calculated with Log-Rank test.</a:t>
            </a:r>
          </a:p>
        </p:txBody>
      </p:sp>
    </p:spTree>
    <p:extLst>
      <p:ext uri="{BB962C8B-B14F-4D97-AF65-F5344CB8AC3E}">
        <p14:creationId xmlns:p14="http://schemas.microsoft.com/office/powerpoint/2010/main" val="1577085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</TotalTime>
  <Words>552</Words>
  <Application>Microsoft Macintosh PowerPoint</Application>
  <PresentationFormat>Custom</PresentationFormat>
  <Paragraphs>22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-Maria Lazaratos</dc:creator>
  <cp:lastModifiedBy>Matthew Dankner</cp:lastModifiedBy>
  <cp:revision>124</cp:revision>
  <dcterms:created xsi:type="dcterms:W3CDTF">2022-10-30T03:49:11Z</dcterms:created>
  <dcterms:modified xsi:type="dcterms:W3CDTF">2023-04-03T01:53:07Z</dcterms:modified>
</cp:coreProperties>
</file>